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5" r:id="rId3"/>
    <p:sldId id="265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38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A8EFE5-018C-4B41-BE3B-E4ED350E5C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BA1C2DB-10F2-48E7-9EE6-A82EDD434C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E33F85-83D3-4FBA-AD16-C4FD8954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E1C54E4-8859-4C56-AC86-809C10712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0DAEEA3-B558-4047-913C-9497EBDF4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3968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B840B62-2CEA-402C-92CE-853420032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2A5E6C0-0436-4985-AADB-ECE9F1C426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8EFBAF8-98D1-4496-8D56-29525AFED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4F918A6-7ABA-4A0E-92D4-DD5F28CBB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0CC7F9F-2511-43CD-B7E8-27C74435A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2724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0DC8DDA-36E0-4DE9-B060-A6284EA182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A45BE2F-2559-4D7C-AFED-604501DCA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4FF949D-B925-46E4-83C7-5B32D628C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4792850-48C8-4279-B361-EAAFFBCD2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A3574AF-AF5C-4626-9AB1-202BBAD5E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7779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4248C4-0663-4C0B-A376-7911203AFF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7835261-2543-4BF9-82D2-B8A90E7A86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962678B-EFEB-4853-A18C-D71689EE4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F0CE9A1-F319-4888-86B5-BE272DDE7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4E69F5-F40E-4B48-AE80-EC599405F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495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4521F6-B446-4FB9-9E8A-2212898B2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E6F52B5-C641-454E-B4FE-CA6868997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9A0FFF-C646-4FF8-B877-F9BCDF07C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B60ABCA-A82B-4B55-B699-F7CAA17A8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0902F37-56CC-43EB-B222-72179B9AD6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580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7B3AEB-BD80-493B-8711-276617E0A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C798BB3-070A-4750-A2D4-E01BB1E0AF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3BBDD49-F25E-4A38-B617-08527FE6DE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DAE9933-808B-4BBA-9BDD-97B3986D8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26563FE-0C6B-4229-809D-8505C6BE3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0C27728-3A11-4D3E-A373-7EF6E4660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2739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4A38DF-2C95-48D3-AFAC-9BFE5B500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557F68E-E285-4BB2-89A1-408C7813F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15A4CA6-C632-4D7C-8D31-1E0D3A5D3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103F329-835C-4871-AC37-D512B3DB4F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635BF7E-A796-4585-95FD-646F800932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3C8E2C0-7372-4102-905A-3D153F2A0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E34CF19-2B51-4912-BDD4-4F28C8D27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2582E4A-B601-4F24-9FA2-9D32790DC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5473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CF6A3DC-56A5-44EB-A1CB-6A17236388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34F0B8E-01AA-4519-8608-B7A35563B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8F06B40-AADA-48BF-AD37-DC83997CA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2A12352-1C70-45FE-8AFB-3565B97F2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562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A97F8A0-15A8-4E4D-84AD-2103D587F7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E3A3712-EBA3-4E57-907C-C69CB2171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879EE95-8579-4213-9C95-8DE30A49C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7098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BE41F4-C81C-4D14-9614-0508C52FCF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03B02A0-B4DC-47B4-8543-C828107BD4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088A48F-1ED7-4637-9CF3-F6BBAA7632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1B9BFB5-F63F-476F-B722-659FFB6E8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AF0E77E-0E8A-4E40-9AF4-4121099CE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A7EB55D-FE37-44F0-95B8-29750F187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9165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230F1B-21C8-4B48-A3B9-20BB4681BF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6422E97-CFEC-4EBC-94C4-FC15798FB3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4810B0B-37E5-4B09-B16A-A5DBF09AE3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1CF7EE4-2C8B-4E95-9521-600AF220A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60C16CA-67ED-456B-822D-348F13F8E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FED5714-D8F4-4CEE-827F-EDB8D5C3D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1097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78BE498-00B7-4D3C-BB50-44300A368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0DCAB98-94D7-4D96-8FFE-DDE4EE12BA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DA58BBA-2E0D-4C9B-850C-CDEACA60F2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C857AF-A105-42A5-BB01-5EE0D9E393DC}" type="datetimeFigureOut">
              <a:rPr lang="de-DE" smtClean="0"/>
              <a:t>01.04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5C1BB86-20B0-4757-B0D4-A60033E7A5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561C592-4D7F-4118-BA48-1A941FC871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411D7-0DD2-4D5D-8FE3-F67B1AA33C4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7887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2739C4-7375-46D8-A234-5CBEA5A2D5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041400"/>
            <a:ext cx="9260541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Screenshots of the user interface of the documentation tool</a:t>
            </a:r>
            <a:endParaRPr lang="de-DE" dirty="0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1F55723-9C26-4A5E-9C42-33157629391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data collection tool for the structured transfer of data from care documentation systems in nursing home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113432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71353328-45D1-40D4-9863-647902D038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1"/>
            <a:ext cx="6830459" cy="6782309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4BA7CE6-AA69-451F-958D-496362628B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3996" y="-1"/>
            <a:ext cx="2879376" cy="685800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6800D19-5802-4C0E-9385-AF976A2A6B86}"/>
              </a:ext>
            </a:extLst>
          </p:cNvPr>
          <p:cNvSpPr txBox="1"/>
          <p:nvPr/>
        </p:nvSpPr>
        <p:spPr>
          <a:xfrm>
            <a:off x="7006728" y="638979"/>
            <a:ext cx="19221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ews of the documentation tool in input mode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6333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4D854ED4-575F-4E32-AA96-4C1F8945B6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072" y="205294"/>
            <a:ext cx="6030454" cy="6184489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D564A5A8-0C07-4281-83D9-53DE895DAD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74" y="205294"/>
            <a:ext cx="5777705" cy="4377723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5EE70AEF-F502-488B-88AA-ECB32AA154EB}"/>
              </a:ext>
            </a:extLst>
          </p:cNvPr>
          <p:cNvSpPr txBox="1"/>
          <p:nvPr/>
        </p:nvSpPr>
        <p:spPr>
          <a:xfrm>
            <a:off x="396609" y="5122845"/>
            <a:ext cx="47592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put forms for the documentation tool relating to awareness, mobility and personal care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97418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reitbild</PresentationFormat>
  <Paragraphs>4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Screenshots of the user interface of the documentation tool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reenshots der eHealth-Plattform</dc:title>
  <dc:creator>Franziska Radicke</dc:creator>
  <cp:lastModifiedBy>Franziska Radicke</cp:lastModifiedBy>
  <cp:revision>2</cp:revision>
  <dcterms:created xsi:type="dcterms:W3CDTF">2026-03-27T16:29:51Z</dcterms:created>
  <dcterms:modified xsi:type="dcterms:W3CDTF">2026-04-01T13:04:53Z</dcterms:modified>
</cp:coreProperties>
</file>